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7" r:id="rId2"/>
    <p:sldId id="258" r:id="rId3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56" userDrawn="1">
          <p15:clr>
            <a:srgbClr val="A4A3A4"/>
          </p15:clr>
        </p15:guide>
        <p15:guide id="2" pos="127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854" autoAdjust="0"/>
    <p:restoredTop sz="93825" autoAdjust="0"/>
  </p:normalViewPr>
  <p:slideViewPr>
    <p:cSldViewPr snapToGrid="0" showGuides="1">
      <p:cViewPr varScale="1">
        <p:scale>
          <a:sx n="103" d="100"/>
          <a:sy n="103" d="100"/>
        </p:scale>
        <p:origin x="1360" y="176"/>
      </p:cViewPr>
      <p:guideLst>
        <p:guide orient="horz" pos="4156"/>
        <p:guide pos="127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5E83C2-7F6A-432B-BBF9-08B64E4B7FFB}" type="datetimeFigureOut">
              <a:rPr kumimoji="1" lang="ja-JP" altLang="en-US" smtClean="0"/>
              <a:t>2023/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E2FD40-1ED0-4557-92D6-92B698B52F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27458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E51CD00-EA3B-B241-B506-60433D8ADA9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78111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E2FD40-1ED0-4557-92D6-92B698B52F3B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97571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126901-BC0E-B11F-539F-994F0F153B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E95EDE4-4351-B0E4-157E-9A5F3DA23A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CD5168-EB67-8E5E-FC2B-4A153C199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116BC-5B3B-4ABC-9E01-824A472E1E23}" type="datetimeFigureOut">
              <a:rPr kumimoji="1" lang="ja-JP" altLang="en-US" smtClean="0"/>
              <a:t>2023/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4CDF340-C022-892D-E552-3EFBBBCA71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19B73AF-AF2C-272A-C5A7-331A11281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E888E-7DDF-4F31-8BD7-0884D50CF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7997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59FE35-965E-21F7-059C-AA0678FC6E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62D2C7F-24ED-CDF0-4FF6-CD373D2C9E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ED63F59-1256-9E84-9337-3E2B3FB94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116BC-5B3B-4ABC-9E01-824A472E1E23}" type="datetimeFigureOut">
              <a:rPr kumimoji="1" lang="ja-JP" altLang="en-US" smtClean="0"/>
              <a:t>2023/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A87467-10CE-AA94-6F04-00AE0DDE5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066200-7B11-25C7-1CB4-042B39806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E888E-7DDF-4F31-8BD7-0884D50CF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7602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9AC21B0-7F9B-2262-5BAD-E48B3206C8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E0EE2F5-B739-6427-7D96-E0A4C7B0D1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CCB5481-8180-5846-ACF3-7DE308BE1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116BC-5B3B-4ABC-9E01-824A472E1E23}" type="datetimeFigureOut">
              <a:rPr kumimoji="1" lang="ja-JP" altLang="en-US" smtClean="0"/>
              <a:t>2023/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4EB3263-5363-8B86-35B7-AF5A15195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A40CF38-D3D7-6DC7-15EB-25527584E9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E888E-7DDF-4F31-8BD7-0884D50CF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2455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A939D3-CDF0-FF28-FD89-F76C599D0E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B07FF14-214B-9F71-B3F4-00F8A7BD5D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EB8C767-0D5F-BF8D-FB3A-9D2927BD2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116BC-5B3B-4ABC-9E01-824A472E1E23}" type="datetimeFigureOut">
              <a:rPr kumimoji="1" lang="ja-JP" altLang="en-US" smtClean="0"/>
              <a:t>2023/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D58F44-E41B-8147-DF1D-822662D953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E217FDF-975B-D252-2D80-F03DC6924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E888E-7DDF-4F31-8BD7-0884D50CF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0629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D1ED69A-C5FA-592A-28A0-D182681969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D0F89F9-D4DF-3F4C-261B-500E02A37B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B5A4031-55C0-A9CA-3164-8F498F2DB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116BC-5B3B-4ABC-9E01-824A472E1E23}" type="datetimeFigureOut">
              <a:rPr kumimoji="1" lang="ja-JP" altLang="en-US" smtClean="0"/>
              <a:t>2023/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D11ACF-50EF-C7CF-CE11-0C5F3EF0C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EB0938A-1DCE-A853-EFDD-85E54F1006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E888E-7DDF-4F31-8BD7-0884D50CF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899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F3F3B1-4E78-4357-6005-B172CCA294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C7E8485-12DA-98D3-BF02-184A9E34A5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BC032A9-A407-8D3A-386B-4641377B55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1BDA589-DD73-47AE-4698-AFF6FC681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116BC-5B3B-4ABC-9E01-824A472E1E23}" type="datetimeFigureOut">
              <a:rPr kumimoji="1" lang="ja-JP" altLang="en-US" smtClean="0"/>
              <a:t>2023/2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CA42B1A-52DB-8F07-F29B-7696413550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949C3DF-99A5-BC2C-7EAF-FCB05DF9D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E888E-7DDF-4F31-8BD7-0884D50CF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1910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C7B092-F932-5526-CB75-20D11436A2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74B70C-CE15-A505-AE23-5BBFC26A63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DB831CF-7EB5-7AA1-5EFB-3BDA66B0B6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C7F9AAE-5B6D-E916-8CFD-2B331E97D7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22506F4-A759-4A39-C56D-C1E207F8A5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F3D44AD-D106-664F-3871-DE96D8484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116BC-5B3B-4ABC-9E01-824A472E1E23}" type="datetimeFigureOut">
              <a:rPr kumimoji="1" lang="ja-JP" altLang="en-US" smtClean="0"/>
              <a:t>2023/2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3CEF273-8ED0-3E37-662C-F76144CEE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AEB28CB-0B2F-8FC4-C05D-9EF85EF85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E888E-7DDF-4F31-8BD7-0884D50CF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999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67023E-3AA4-78A6-06C0-A44AEE8854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844DFBB-E0BC-F024-6A54-AA6D472463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116BC-5B3B-4ABC-9E01-824A472E1E23}" type="datetimeFigureOut">
              <a:rPr kumimoji="1" lang="ja-JP" altLang="en-US" smtClean="0"/>
              <a:t>2023/2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2562536-427A-9A59-C9E7-5823E3D27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7F67006-2FFC-DE14-FEAC-925790D66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E888E-7DDF-4F31-8BD7-0884D50CF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564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7268366-C154-4627-FAD0-21D531F704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116BC-5B3B-4ABC-9E01-824A472E1E23}" type="datetimeFigureOut">
              <a:rPr kumimoji="1" lang="ja-JP" altLang="en-US" smtClean="0"/>
              <a:t>2023/2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3EEAE76-CDD4-F5FA-5B71-448A8BDCAE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802C9C5-E21B-8FB4-AC56-780C8F531A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E888E-7DDF-4F31-8BD7-0884D50CF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2563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BB4E15D-4148-33BC-2561-E0CFF420D3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51F7021-5C1A-39B1-3422-B9893B9361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5675C2C-CB68-3DD9-CBD8-ADEFE8B538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C9A215E-0450-B0CB-FD30-5716F3034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116BC-5B3B-4ABC-9E01-824A472E1E23}" type="datetimeFigureOut">
              <a:rPr kumimoji="1" lang="ja-JP" altLang="en-US" smtClean="0"/>
              <a:t>2023/2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4D589FA-5B98-91E8-BF60-719A0330C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99B45B9-42C0-5446-3D96-050CCD697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E888E-7DDF-4F31-8BD7-0884D50CF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5813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51F14C-4163-CF7D-AF25-7D9EE4184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7D7FCE9-AECD-FC67-2222-15AA261C4B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C199098-4C58-A6D1-3690-EB2440DBC3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68A9F82-3279-8100-7C30-C62A296A59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116BC-5B3B-4ABC-9E01-824A472E1E23}" type="datetimeFigureOut">
              <a:rPr kumimoji="1" lang="ja-JP" altLang="en-US" smtClean="0"/>
              <a:t>2023/2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B177A79-B659-62DE-BF16-604F2895C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623D3D6-10E1-B2DA-7118-8E9DEE4E7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E888E-7DDF-4F31-8BD7-0884D50CF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5786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4784E68-BBDC-BFCE-BF4E-A0FDB2549A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2BEDC34-ACCD-8052-A685-9B41E8033E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BE8477-14E5-50FD-7E1B-9C244D0F63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9116BC-5B3B-4ABC-9E01-824A472E1E23}" type="datetimeFigureOut">
              <a:rPr kumimoji="1" lang="ja-JP" altLang="en-US" smtClean="0"/>
              <a:t>2023/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ACF84C-6E83-C39A-54CB-AD59AD0369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83BF21B-BF53-AB80-4E82-40F89C0F1A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1E888E-7DDF-4F31-8BD7-0884D50CF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9285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1A76EEFB-7FB1-129C-18D6-44ECDFB2D1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75034" y="1866123"/>
            <a:ext cx="2971800" cy="29718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CD8570CC-87EF-0D30-8756-1F513408A2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4185" y="1866123"/>
            <a:ext cx="2971800" cy="29718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36811BD3-166B-2D03-FB8B-01059495237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92143" y="1843263"/>
            <a:ext cx="3052665" cy="3052665"/>
          </a:xfrm>
          <a:prstGeom prst="rect">
            <a:avLst/>
          </a:prstGeom>
        </p:spPr>
      </p:pic>
      <p:sp>
        <p:nvSpPr>
          <p:cNvPr id="6" name="テキスト ボックス 941">
            <a:extLst>
              <a:ext uri="{FF2B5EF4-FFF2-40B4-BE49-F238E27FC236}">
                <a16:creationId xmlns:a16="http://schemas.microsoft.com/office/drawing/2014/main" id="{A0D12DEA-BF6B-FE1C-1741-2650A49BABC2}"/>
              </a:ext>
            </a:extLst>
          </p:cNvPr>
          <p:cNvSpPr txBox="1"/>
          <p:nvPr/>
        </p:nvSpPr>
        <p:spPr>
          <a:xfrm>
            <a:off x="1964074" y="4196196"/>
            <a:ext cx="1689364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UC</a:t>
            </a:r>
            <a:r>
              <a:rPr lang="ja-JP" altLang="en-US" sz="105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0.72 (0.65-0.79)</a:t>
            </a:r>
          </a:p>
        </p:txBody>
      </p:sp>
      <p:sp>
        <p:nvSpPr>
          <p:cNvPr id="8" name="テキスト ボックス 941">
            <a:extLst>
              <a:ext uri="{FF2B5EF4-FFF2-40B4-BE49-F238E27FC236}">
                <a16:creationId xmlns:a16="http://schemas.microsoft.com/office/drawing/2014/main" id="{DDA92F7A-7331-A2A9-4EC5-A1F04BBEC741}"/>
              </a:ext>
            </a:extLst>
          </p:cNvPr>
          <p:cNvSpPr txBox="1"/>
          <p:nvPr/>
        </p:nvSpPr>
        <p:spPr>
          <a:xfrm>
            <a:off x="5613818" y="4196196"/>
            <a:ext cx="1689364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UC</a:t>
            </a:r>
            <a:r>
              <a:rPr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0.59</a:t>
            </a:r>
            <a:r>
              <a:rPr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0.52-0.68)</a:t>
            </a:r>
          </a:p>
        </p:txBody>
      </p:sp>
      <p:sp>
        <p:nvSpPr>
          <p:cNvPr id="9" name="テキスト ボックス 941">
            <a:extLst>
              <a:ext uri="{FF2B5EF4-FFF2-40B4-BE49-F238E27FC236}">
                <a16:creationId xmlns:a16="http://schemas.microsoft.com/office/drawing/2014/main" id="{D80D5F4F-A13B-3975-DA03-B6A1D7373183}"/>
              </a:ext>
            </a:extLst>
          </p:cNvPr>
          <p:cNvSpPr txBox="1"/>
          <p:nvPr/>
        </p:nvSpPr>
        <p:spPr>
          <a:xfrm>
            <a:off x="9070065" y="4212374"/>
            <a:ext cx="1689364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UC</a:t>
            </a:r>
            <a:r>
              <a:rPr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0.63</a:t>
            </a:r>
            <a:r>
              <a:rPr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0.56-0.71)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46E545B-1F82-9559-19F8-10BD6EA82AAD}"/>
              </a:ext>
            </a:extLst>
          </p:cNvPr>
          <p:cNvSpPr txBox="1"/>
          <p:nvPr/>
        </p:nvSpPr>
        <p:spPr>
          <a:xfrm>
            <a:off x="8413290" y="1611880"/>
            <a:ext cx="2183364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LR/Alb</a:t>
            </a:r>
          </a:p>
          <a:p>
            <a:pPr algn="ctr"/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5D905D6-3FE1-328D-6AB2-9CB9E787472A}"/>
              </a:ext>
            </a:extLst>
          </p:cNvPr>
          <p:cNvSpPr txBox="1"/>
          <p:nvPr/>
        </p:nvSpPr>
        <p:spPr>
          <a:xfrm>
            <a:off x="1380403" y="1609129"/>
            <a:ext cx="218336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PNI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C62764B-F126-A98C-E09F-51159C058C7E}"/>
              </a:ext>
            </a:extLst>
          </p:cNvPr>
          <p:cNvSpPr txBox="1"/>
          <p:nvPr/>
        </p:nvSpPr>
        <p:spPr>
          <a:xfrm>
            <a:off x="4985453" y="1609129"/>
            <a:ext cx="218336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LR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59B3F1DE-7898-4A16-E75B-AF2E7A38BC92}"/>
              </a:ext>
            </a:extLst>
          </p:cNvPr>
          <p:cNvSpPr/>
          <p:nvPr/>
        </p:nvSpPr>
        <p:spPr>
          <a:xfrm>
            <a:off x="-13869" y="4260"/>
            <a:ext cx="1218200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ja-JP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36601903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9" name="図 138">
            <a:extLst>
              <a:ext uri="{FF2B5EF4-FFF2-40B4-BE49-F238E27FC236}">
                <a16:creationId xmlns:a16="http://schemas.microsoft.com/office/drawing/2014/main" id="{DEC6AF66-9068-795D-1B2F-F11C426A1D00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10489" t="11267" r="4032" b="15875"/>
          <a:stretch/>
        </p:blipFill>
        <p:spPr>
          <a:xfrm>
            <a:off x="2242515" y="549937"/>
            <a:ext cx="3600000" cy="2881236"/>
          </a:xfrm>
          <a:prstGeom prst="rect">
            <a:avLst/>
          </a:prstGeom>
        </p:spPr>
      </p:pic>
      <p:pic>
        <p:nvPicPr>
          <p:cNvPr id="141" name="図 140">
            <a:extLst>
              <a:ext uri="{FF2B5EF4-FFF2-40B4-BE49-F238E27FC236}">
                <a16:creationId xmlns:a16="http://schemas.microsoft.com/office/drawing/2014/main" id="{1AC3F385-763B-EF3E-58A5-0121DB681EA5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l="10772" t="11806" r="3747" b="15336"/>
          <a:stretch/>
        </p:blipFill>
        <p:spPr>
          <a:xfrm>
            <a:off x="2242515" y="3742721"/>
            <a:ext cx="3600000" cy="2880000"/>
          </a:xfrm>
          <a:prstGeom prst="rect">
            <a:avLst/>
          </a:prstGeom>
        </p:spPr>
      </p:pic>
      <p:pic>
        <p:nvPicPr>
          <p:cNvPr id="143" name="図 142">
            <a:extLst>
              <a:ext uri="{FF2B5EF4-FFF2-40B4-BE49-F238E27FC236}">
                <a16:creationId xmlns:a16="http://schemas.microsoft.com/office/drawing/2014/main" id="{C6897694-80D9-1BE0-1DDE-76D1CF63A246}"/>
              </a:ext>
            </a:extLst>
          </p:cNvPr>
          <p:cNvPicPr>
            <a:picLocks/>
          </p:cNvPicPr>
          <p:nvPr/>
        </p:nvPicPr>
        <p:blipFill rotWithShape="1">
          <a:blip r:embed="rId5"/>
          <a:srcRect l="10027" t="10986" r="4493" b="16156"/>
          <a:stretch/>
        </p:blipFill>
        <p:spPr>
          <a:xfrm>
            <a:off x="6333994" y="551173"/>
            <a:ext cx="3600000" cy="2880000"/>
          </a:xfrm>
          <a:prstGeom prst="rect">
            <a:avLst/>
          </a:prstGeom>
        </p:spPr>
      </p:pic>
      <p:pic>
        <p:nvPicPr>
          <p:cNvPr id="145" name="図 144">
            <a:extLst>
              <a:ext uri="{FF2B5EF4-FFF2-40B4-BE49-F238E27FC236}">
                <a16:creationId xmlns:a16="http://schemas.microsoft.com/office/drawing/2014/main" id="{B3A49CDF-0ED8-02D2-A310-87C90566E32A}"/>
              </a:ext>
            </a:extLst>
          </p:cNvPr>
          <p:cNvPicPr>
            <a:picLocks/>
          </p:cNvPicPr>
          <p:nvPr/>
        </p:nvPicPr>
        <p:blipFill rotWithShape="1">
          <a:blip r:embed="rId6"/>
          <a:srcRect l="10752" t="11662" r="3768" b="15480"/>
          <a:stretch/>
        </p:blipFill>
        <p:spPr>
          <a:xfrm>
            <a:off x="6358378" y="3735347"/>
            <a:ext cx="3600000" cy="2880000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B5B67A56-1724-F89E-EC70-3B68DB0932B2}"/>
              </a:ext>
            </a:extLst>
          </p:cNvPr>
          <p:cNvSpPr/>
          <p:nvPr/>
        </p:nvSpPr>
        <p:spPr>
          <a:xfrm>
            <a:off x="-13869" y="4260"/>
            <a:ext cx="1218200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ja-JP" altLang="en-US" sz="1600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70AD857-946B-3FDB-BB2F-572B6DEEEED7}"/>
              </a:ext>
            </a:extLst>
          </p:cNvPr>
          <p:cNvSpPr txBox="1"/>
          <p:nvPr/>
        </p:nvSpPr>
        <p:spPr>
          <a:xfrm>
            <a:off x="2544314" y="211383"/>
            <a:ext cx="321056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Stage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 I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C71456C-D9A9-F122-A0E3-833CA3E2489E}"/>
              </a:ext>
            </a:extLst>
          </p:cNvPr>
          <p:cNvSpPr txBox="1"/>
          <p:nvPr/>
        </p:nvSpPr>
        <p:spPr>
          <a:xfrm>
            <a:off x="6553098" y="211383"/>
            <a:ext cx="321056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Stage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 II/III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969C3008-F4DC-5A98-A321-C6B14D3E464B}"/>
              </a:ext>
            </a:extLst>
          </p:cNvPr>
          <p:cNvSpPr/>
          <p:nvPr/>
        </p:nvSpPr>
        <p:spPr>
          <a:xfrm>
            <a:off x="3657599" y="2630466"/>
            <a:ext cx="1077239" cy="5260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05C87E35-8AC9-1F51-76DB-E446A4C9A4D2}"/>
              </a:ext>
            </a:extLst>
          </p:cNvPr>
          <p:cNvSpPr/>
          <p:nvPr/>
        </p:nvSpPr>
        <p:spPr>
          <a:xfrm>
            <a:off x="7755698" y="2630466"/>
            <a:ext cx="1077239" cy="5260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DA9DF13B-7F3F-1A40-F407-C689EA81D659}"/>
              </a:ext>
            </a:extLst>
          </p:cNvPr>
          <p:cNvSpPr/>
          <p:nvPr/>
        </p:nvSpPr>
        <p:spPr>
          <a:xfrm>
            <a:off x="3657599" y="5814165"/>
            <a:ext cx="1077239" cy="5260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55D61B71-594C-1778-6539-71DB557534C5}"/>
              </a:ext>
            </a:extLst>
          </p:cNvPr>
          <p:cNvSpPr/>
          <p:nvPr/>
        </p:nvSpPr>
        <p:spPr>
          <a:xfrm>
            <a:off x="7755698" y="5814165"/>
            <a:ext cx="1077239" cy="5260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944">
            <a:extLst>
              <a:ext uri="{FF2B5EF4-FFF2-40B4-BE49-F238E27FC236}">
                <a16:creationId xmlns:a16="http://schemas.microsoft.com/office/drawing/2014/main" id="{FD6AD047-559B-A623-1ED6-538ED5CE3CB6}"/>
              </a:ext>
            </a:extLst>
          </p:cNvPr>
          <p:cNvSpPr txBox="1"/>
          <p:nvPr/>
        </p:nvSpPr>
        <p:spPr>
          <a:xfrm rot="16200000">
            <a:off x="1212225" y="1715110"/>
            <a:ext cx="156910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verall survival rate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44">
            <a:extLst>
              <a:ext uri="{FF2B5EF4-FFF2-40B4-BE49-F238E27FC236}">
                <a16:creationId xmlns:a16="http://schemas.microsoft.com/office/drawing/2014/main" id="{3066E826-DC1A-EEC7-9068-93623AEA6169}"/>
              </a:ext>
            </a:extLst>
          </p:cNvPr>
          <p:cNvSpPr txBox="1"/>
          <p:nvPr/>
        </p:nvSpPr>
        <p:spPr>
          <a:xfrm rot="16200000">
            <a:off x="5303703" y="1715110"/>
            <a:ext cx="156910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verall survival rate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944">
            <a:extLst>
              <a:ext uri="{FF2B5EF4-FFF2-40B4-BE49-F238E27FC236}">
                <a16:creationId xmlns:a16="http://schemas.microsoft.com/office/drawing/2014/main" id="{38599896-CA5E-C5C1-D2D8-45FF4A1D6440}"/>
              </a:ext>
            </a:extLst>
          </p:cNvPr>
          <p:cNvSpPr txBox="1"/>
          <p:nvPr/>
        </p:nvSpPr>
        <p:spPr>
          <a:xfrm rot="16200000">
            <a:off x="914601" y="5044542"/>
            <a:ext cx="216435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elapse free survival rate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944">
            <a:extLst>
              <a:ext uri="{FF2B5EF4-FFF2-40B4-BE49-F238E27FC236}">
                <a16:creationId xmlns:a16="http://schemas.microsoft.com/office/drawing/2014/main" id="{AF3ECF35-9936-3107-3AF5-FA7A9699521C}"/>
              </a:ext>
            </a:extLst>
          </p:cNvPr>
          <p:cNvSpPr txBox="1"/>
          <p:nvPr/>
        </p:nvSpPr>
        <p:spPr>
          <a:xfrm rot="16200000">
            <a:off x="5006079" y="5051916"/>
            <a:ext cx="216435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elapse free survival rate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93">
            <a:extLst>
              <a:ext uri="{FF2B5EF4-FFF2-40B4-BE49-F238E27FC236}">
                <a16:creationId xmlns:a16="http://schemas.microsoft.com/office/drawing/2014/main" id="{BA1CF1E7-BEFC-8C79-B66E-A54172AADE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40879" y="3506597"/>
            <a:ext cx="161743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>
                <a:solidFill>
                  <a:srgbClr val="000000"/>
                </a:solidFill>
              </a:rPr>
              <a:t>Time after surgery (years)</a:t>
            </a:r>
            <a:endParaRPr kumimoji="0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" name="Rectangle 193">
            <a:extLst>
              <a:ext uri="{FF2B5EF4-FFF2-40B4-BE49-F238E27FC236}">
                <a16:creationId xmlns:a16="http://schemas.microsoft.com/office/drawing/2014/main" id="{5C7B69B1-77B1-F998-86C8-61D94BFD32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85602" y="3506597"/>
            <a:ext cx="161743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>
                <a:solidFill>
                  <a:srgbClr val="000000"/>
                </a:solidFill>
              </a:rPr>
              <a:t>Time after surgery (years)</a:t>
            </a:r>
            <a:endParaRPr kumimoji="0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" name="Rectangle 193">
            <a:extLst>
              <a:ext uri="{FF2B5EF4-FFF2-40B4-BE49-F238E27FC236}">
                <a16:creationId xmlns:a16="http://schemas.microsoft.com/office/drawing/2014/main" id="{2C091E6B-C425-B22A-8403-E0DC6EEC1B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40879" y="6615347"/>
            <a:ext cx="161743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>
                <a:solidFill>
                  <a:srgbClr val="000000"/>
                </a:solidFill>
              </a:rPr>
              <a:t>Time after surgery (years)</a:t>
            </a:r>
            <a:endParaRPr kumimoji="0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7" name="Rectangle 193">
            <a:extLst>
              <a:ext uri="{FF2B5EF4-FFF2-40B4-BE49-F238E27FC236}">
                <a16:creationId xmlns:a16="http://schemas.microsoft.com/office/drawing/2014/main" id="{6BE9A0C8-9483-8DF2-0874-3FE1191B75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85602" y="6615347"/>
            <a:ext cx="161743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>
                <a:solidFill>
                  <a:srgbClr val="000000"/>
                </a:solidFill>
              </a:rPr>
              <a:t>Time after surgery (years)</a:t>
            </a:r>
            <a:endParaRPr kumimoji="0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5E670E2-3FDA-DC03-6313-4FE7501BAEB6}"/>
              </a:ext>
            </a:extLst>
          </p:cNvPr>
          <p:cNvSpPr txBox="1"/>
          <p:nvPr/>
        </p:nvSpPr>
        <p:spPr>
          <a:xfrm>
            <a:off x="498731" y="5006070"/>
            <a:ext cx="1152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3Y-RFS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38F6C06-92A5-58CE-D04A-D7E36A2EE987}"/>
              </a:ext>
            </a:extLst>
          </p:cNvPr>
          <p:cNvSpPr txBox="1"/>
          <p:nvPr/>
        </p:nvSpPr>
        <p:spPr>
          <a:xfrm>
            <a:off x="509106" y="1676637"/>
            <a:ext cx="1152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3Y-OS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2D661C0-DF2F-B4BB-0A9F-5E8034BBEAA3}"/>
              </a:ext>
            </a:extLst>
          </p:cNvPr>
          <p:cNvSpPr txBox="1"/>
          <p:nvPr/>
        </p:nvSpPr>
        <p:spPr>
          <a:xfrm>
            <a:off x="3406245" y="1993651"/>
            <a:ext cx="2348629" cy="738664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txBody>
          <a:bodyPr wrap="square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LR/Alb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99.0 %</a:t>
            </a:r>
          </a:p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LR/Alb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95.2 %</a:t>
            </a:r>
          </a:p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 = 0.40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2185967D-EEC8-70BF-7CE9-BF074D77AC69}"/>
              </a:ext>
            </a:extLst>
          </p:cNvPr>
          <p:cNvCxnSpPr/>
          <p:nvPr/>
        </p:nvCxnSpPr>
        <p:spPr>
          <a:xfrm>
            <a:off x="3551464" y="2147207"/>
            <a:ext cx="35922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B3BEDD18-EB5D-F619-3EA6-F2004A6DC7D8}"/>
              </a:ext>
            </a:extLst>
          </p:cNvPr>
          <p:cNvCxnSpPr/>
          <p:nvPr/>
        </p:nvCxnSpPr>
        <p:spPr>
          <a:xfrm>
            <a:off x="3551464" y="2362983"/>
            <a:ext cx="359229" cy="0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9F8C387-F5D6-8060-C346-EADA472BC3F0}"/>
              </a:ext>
            </a:extLst>
          </p:cNvPr>
          <p:cNvSpPr txBox="1"/>
          <p:nvPr/>
        </p:nvSpPr>
        <p:spPr>
          <a:xfrm>
            <a:off x="7585365" y="1993651"/>
            <a:ext cx="2348629" cy="738664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txBody>
          <a:bodyPr wrap="square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LR/Alb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94.5 %</a:t>
            </a:r>
          </a:p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LR/Alb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74.3 %</a:t>
            </a:r>
          </a:p>
          <a:p>
            <a:pPr algn="r"/>
            <a:r>
              <a:rPr kumimoji="1" lang="en-US" altLang="ja-JP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= 0.005</a:t>
            </a:r>
            <a:endParaRPr kumimoji="1" lang="ja-JP" altLang="en-US" sz="14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4BAF8255-70FD-C446-B9C7-AA9636312451}"/>
              </a:ext>
            </a:extLst>
          </p:cNvPr>
          <p:cNvCxnSpPr/>
          <p:nvPr/>
        </p:nvCxnSpPr>
        <p:spPr>
          <a:xfrm>
            <a:off x="7730584" y="2147207"/>
            <a:ext cx="35922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A4D1A533-8294-2261-EDA9-A248C22F4478}"/>
              </a:ext>
            </a:extLst>
          </p:cNvPr>
          <p:cNvCxnSpPr/>
          <p:nvPr/>
        </p:nvCxnSpPr>
        <p:spPr>
          <a:xfrm>
            <a:off x="7730584" y="2362983"/>
            <a:ext cx="359229" cy="0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EEA3242-2376-E420-3C9B-7479BBC5D158}"/>
              </a:ext>
            </a:extLst>
          </p:cNvPr>
          <p:cNvSpPr txBox="1"/>
          <p:nvPr/>
        </p:nvSpPr>
        <p:spPr>
          <a:xfrm>
            <a:off x="3406245" y="5169744"/>
            <a:ext cx="2348629" cy="738664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txBody>
          <a:bodyPr wrap="square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LR/Alb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97.0 %</a:t>
            </a:r>
          </a:p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LR/Alb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94.3 %</a:t>
            </a:r>
          </a:p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 = 0.69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A02AA234-70B2-E265-4CD8-27B8CED95169}"/>
              </a:ext>
            </a:extLst>
          </p:cNvPr>
          <p:cNvCxnSpPr/>
          <p:nvPr/>
        </p:nvCxnSpPr>
        <p:spPr>
          <a:xfrm>
            <a:off x="3551464" y="5323300"/>
            <a:ext cx="35922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22575374-0C3F-9E9B-88FC-4E03C0E8518F}"/>
              </a:ext>
            </a:extLst>
          </p:cNvPr>
          <p:cNvCxnSpPr/>
          <p:nvPr/>
        </p:nvCxnSpPr>
        <p:spPr>
          <a:xfrm>
            <a:off x="3551464" y="5539076"/>
            <a:ext cx="359229" cy="0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2FBFBF16-32A4-8AA3-41B9-608761328FD7}"/>
              </a:ext>
            </a:extLst>
          </p:cNvPr>
          <p:cNvSpPr txBox="1"/>
          <p:nvPr/>
        </p:nvSpPr>
        <p:spPr>
          <a:xfrm>
            <a:off x="7585365" y="5169744"/>
            <a:ext cx="2348629" cy="738664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txBody>
          <a:bodyPr wrap="square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LR/Alb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92.0 %</a:t>
            </a:r>
          </a:p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LR/Alb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63.7 %</a:t>
            </a:r>
          </a:p>
          <a:p>
            <a:pPr algn="r"/>
            <a:r>
              <a:rPr kumimoji="1" lang="en-US" altLang="ja-JP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= 0.002</a:t>
            </a:r>
            <a:endParaRPr kumimoji="1" lang="ja-JP" altLang="en-US" sz="14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57B85B9E-DAE2-5C77-49D9-1896E3D1C266}"/>
              </a:ext>
            </a:extLst>
          </p:cNvPr>
          <p:cNvCxnSpPr/>
          <p:nvPr/>
        </p:nvCxnSpPr>
        <p:spPr>
          <a:xfrm>
            <a:off x="7730584" y="5323300"/>
            <a:ext cx="35922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EA1778BA-D9F5-C549-150F-538D5866B4E4}"/>
              </a:ext>
            </a:extLst>
          </p:cNvPr>
          <p:cNvCxnSpPr/>
          <p:nvPr/>
        </p:nvCxnSpPr>
        <p:spPr>
          <a:xfrm>
            <a:off x="7730584" y="5539076"/>
            <a:ext cx="359229" cy="0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86863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9</TotalTime>
  <Words>134</Words>
  <Application>Microsoft Macintosh PowerPoint</Application>
  <PresentationFormat>ワイド画面</PresentationFormat>
  <Paragraphs>34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橋本 至</dc:creator>
  <cp:lastModifiedBy> </cp:lastModifiedBy>
  <cp:revision>35</cp:revision>
  <cp:lastPrinted>2022-05-19T06:46:00Z</cp:lastPrinted>
  <dcterms:created xsi:type="dcterms:W3CDTF">2022-05-18T08:43:23Z</dcterms:created>
  <dcterms:modified xsi:type="dcterms:W3CDTF">2023-02-02T15:44:28Z</dcterms:modified>
</cp:coreProperties>
</file>